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202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56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02500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9922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18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192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468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692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605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2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03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20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CB0D9-4F87-AE4A-8050-BD6CB1930F68}" type="datetimeFigureOut">
              <a:rPr lang="en-US" smtClean="0"/>
              <a:t>03/12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95A458-274C-FC4A-A27C-57D1D0E3BE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8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762000"/>
            <a:ext cx="3082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4-figure supplement 2A 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45218"/>
              </p:ext>
            </p:extLst>
          </p:nvPr>
        </p:nvGraphicFramePr>
        <p:xfrm>
          <a:off x="3165317" y="3505200"/>
          <a:ext cx="1663700" cy="485775"/>
        </p:xfrm>
        <a:graphic>
          <a:graphicData uri="http://schemas.openxmlformats.org/drawingml/2006/table">
            <a:tbl>
              <a:tblPr/>
              <a:tblGrid>
                <a:gridCol w="740438">
                  <a:extLst>
                    <a:ext uri="{9D8B030D-6E8A-4147-A177-3AD203B41FA5}">
                      <a16:colId xmlns:a16="http://schemas.microsoft.com/office/drawing/2014/main" xmlns="" val="2643376263"/>
                    </a:ext>
                  </a:extLst>
                </a:gridCol>
                <a:gridCol w="923262">
                  <a:extLst>
                    <a:ext uri="{9D8B030D-6E8A-4147-A177-3AD203B41FA5}">
                      <a16:colId xmlns:a16="http://schemas.microsoft.com/office/drawing/2014/main" xmlns="" val="254197840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1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812780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0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20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09061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19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04633557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048000" y="2971800"/>
            <a:ext cx="1588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roup 1         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7326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14400" y="762000"/>
            <a:ext cx="3073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4-figure supplement 2C </a:t>
            </a:r>
            <a:endParaRPr lang="en-US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8390594"/>
              </p:ext>
            </p:extLst>
          </p:nvPr>
        </p:nvGraphicFramePr>
        <p:xfrm>
          <a:off x="2362200" y="1981197"/>
          <a:ext cx="3657600" cy="29718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192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192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88429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wild typ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Ad-b-gal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>
                          <a:effectLst/>
                        </a:rPr>
                        <a:t>Ad-lncEGFL7OS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670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081.18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871.876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667.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014.4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3136.27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605.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915.3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8788.22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649.5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6552.3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9076.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5289.5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10052.2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47919">
                <a:tc>
                  <a:txBody>
                    <a:bodyPr/>
                    <a:lstStyle/>
                    <a:p>
                      <a:pPr algn="r" fontAlgn="b"/>
                      <a:endParaRPr lang="en-US" sz="10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7156.5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8112.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6462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47</Words>
  <Application>Microsoft Macintosh PowerPoint</Application>
  <PresentationFormat>On-screen Show (4:3)</PresentationFormat>
  <Paragraphs>2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a</dc:creator>
  <cp:lastModifiedBy>Susanna</cp:lastModifiedBy>
  <cp:revision>12</cp:revision>
  <dcterms:created xsi:type="dcterms:W3CDTF">2018-12-03T10:45:52Z</dcterms:created>
  <dcterms:modified xsi:type="dcterms:W3CDTF">2018-12-03T10:59:43Z</dcterms:modified>
</cp:coreProperties>
</file>